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73" r:id="rId4"/>
    <p:sldId id="274" r:id="rId5"/>
    <p:sldId id="261" r:id="rId6"/>
    <p:sldId id="275" r:id="rId7"/>
    <p:sldId id="276" r:id="rId8"/>
  </p:sldIdLst>
  <p:sldSz cx="12192000" cy="6858000"/>
  <p:notesSz cx="6819900" cy="9918700"/>
  <p:defaultTextStyle>
    <a:defPPr>
      <a:defRPr lang="en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Jakob Mueller" initials="JM" lastIdx="3" clrIdx="0">
    <p:extLst>
      <p:ext uri="{19B8F6BF-5375-455C-9EA6-DF929625EA0E}">
        <p15:presenceInfo xmlns:p15="http://schemas.microsoft.com/office/powerpoint/2012/main" userId="S-1-5-21-2082565588-2041397725-3253895685-1277" providerId="AD"/>
      </p:ext>
    </p:extLst>
  </p:cmAuthor>
  <p:cmAuthor id="2" name="kempenaers" initials="k" lastIdx="1" clrIdx="1">
    <p:extLst>
      <p:ext uri="{19B8F6BF-5375-455C-9EA6-DF929625EA0E}">
        <p15:presenceInfo xmlns:p15="http://schemas.microsoft.com/office/powerpoint/2012/main" userId="kempenaers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25" autoAdjust="0"/>
    <p:restoredTop sz="94660"/>
  </p:normalViewPr>
  <p:slideViewPr>
    <p:cSldViewPr snapToGrid="0">
      <p:cViewPr varScale="1">
        <p:scale>
          <a:sx n="105" d="100"/>
          <a:sy n="105" d="100"/>
        </p:scale>
        <p:origin x="120" y="12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A4D16E-928C-49C8-A073-01FD0E37A5E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FEFD5D1-CF1B-40F4-86A4-F16C4DD7F1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CC1FBC8-875C-41A7-B16B-843367A0C8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B2FCBEB-C70D-42D0-A476-CCD9F4DF45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FDEAE1B-981B-4147-8070-C3F667420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4449606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AD6E434-3FA0-4A0C-9186-908AA67E34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05D0D99-B7A8-4076-9AA5-DCB7BF517C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F12FD40-B83D-4B98-ADCB-3B92F86FB3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6B7DF2-7DD3-4AD0-8FFC-26E8866BDF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9C2CBB-3DB7-4DC9-8AB9-D3116107722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34290751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43E08E0-9316-4504-BFE7-68B74F7AC98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6630513-C13D-4D63-90B5-7648D9C85A5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4C292FE-5D8C-49E1-B5FB-1AA2B8E61C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73CAEFB-2294-4F29-B704-6B17850A18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7FFDE2E-8704-4D27-AE15-23DD1A195F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517298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9B78A3-8B4D-445B-93EC-7E71153CA51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C021715-D497-4154-982C-AA2651F9811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E34C702-2A89-4EFB-A884-9021397D1C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5CC1C7-BD93-4939-AA12-1421475B733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5D433D6-A54C-40B2-AAFF-3FDE37698C8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26692415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D7E5CF-96F9-4ABE-9EE5-89489C185F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45776E3-1D4C-4E4B-B1B9-B7F36927B8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36DB20-F917-4C1E-BA64-BC4A1CE1DB5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51955C7-91FE-43E6-8863-FDF6CC4DF98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1AB848E-9D0B-453C-85B8-0F3815D742F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8698130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91030F-DBA1-4A1E-9CE3-F77E93C4535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2A629FD-F3A7-4928-8E25-F13A37C9617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1081ED5-75D5-4EAA-817A-D5F1F3AB0BB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E47086-4727-41E7-A753-B0198696F10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E99D0C6-AE01-4E1F-9406-FF3DA6A4DF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8C7E032-C476-4827-89C9-096D1B689D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93865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640512F-000F-4D70-AD2B-66BF312C914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79AB207-21B5-4336-AFF5-4DA898F56DE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2BF5326-FDBB-4767-9426-AD390CB4B98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97568BE-A692-452E-B8DF-0ECD48F350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EF279F4-9893-4DBA-AB71-E8C1FC31496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255522F-0EA6-49DA-8B7B-4342244782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2743F16-AC59-4E41-A17B-9DE2CEAEFF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A6618EE-85CE-448F-9F3A-E16977E045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86954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9C8E9D-CB58-41C8-A736-D15EAA50F9E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D69107-75A8-4A0F-B1F1-176728C9C2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310F0B-89CC-4A8B-ADE8-07E0202B082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31D11E30-0FE1-4B7C-9272-1496CE959F8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411269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740856C-0937-4726-BC9A-735EC3155FE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7DA54B-9407-44A8-8A0B-9A587AB647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98D2499-FEB7-494B-B20D-2C15BC2F39A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6565713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DB29ECA-BE2C-4062-A2F0-409F115255C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7B25A16-EA90-49A5-AC9A-0C816C53DA8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8F135CF-EED7-43FD-8598-CCA39FBBB27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1F833E0-3E71-4855-B9CA-AA2DD5181A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55BA024-DC00-470B-92F1-4B9C2172F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AFF025F-F429-4C4C-8209-E007F71B2E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883550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4E556A-9228-4E18-A293-84A8B1AA672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7E5AF1F-688F-444F-98B7-CA41C0F3587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DE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04F4F38-3EB5-4CA1-9457-DA33002036E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81582ED-1C76-4B13-82A8-0415D9DEDF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34636E2-686E-41D9-BFDE-E1C3EA7378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DE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252D27-43D9-4E08-B41F-A6DF670FCD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17087588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22CF9AE-1E23-4781-B907-35DEA6BAC5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DE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87C975A-5F92-48DA-9DB6-3DDE0D4AE04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DE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30D923B-CBCF-4650-B8C1-3D860BCDE052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4542DC-B0D6-46CC-8E42-538FF78AFB03}" type="datetimeFigureOut">
              <a:rPr lang="en-DE" smtClean="0"/>
              <a:t>19/04/2023</a:t>
            </a:fld>
            <a:endParaRPr lang="en-DE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E21B988-C638-4DE0-A92E-B0DEC7C06EB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DE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08F540B-FCA2-418B-A5D1-B968890959EB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28F1C1-E695-41F3-9338-ED746B97B5AC}" type="slidenum">
              <a:rPr lang="en-DE" smtClean="0"/>
              <a:t>‹#›</a:t>
            </a:fld>
            <a:endParaRPr lang="en-DE"/>
          </a:p>
        </p:txBody>
      </p:sp>
    </p:spTree>
    <p:extLst>
      <p:ext uri="{BB962C8B-B14F-4D97-AF65-F5344CB8AC3E}">
        <p14:creationId xmlns:p14="http://schemas.microsoft.com/office/powerpoint/2010/main" val="6839623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png"/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70571A77-5779-4392-8EAC-E60AF4D16FFD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13902" y="1133857"/>
            <a:ext cx="8668571" cy="2899168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6124D5B-A53C-426E-806C-09A290FF0278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4801" y="680150"/>
            <a:ext cx="3317079" cy="3396952"/>
          </a:xfrm>
          <a:prstGeom prst="rect">
            <a:avLst/>
          </a:prstGeom>
        </p:spPr>
      </p:pic>
      <p:sp>
        <p:nvSpPr>
          <p:cNvPr id="10" name="Rectangle 9">
            <a:extLst>
              <a:ext uri="{FF2B5EF4-FFF2-40B4-BE49-F238E27FC236}">
                <a16:creationId xmlns:a16="http://schemas.microsoft.com/office/drawing/2014/main" id="{B87CBE49-7380-4E78-B009-BDE90566859E}"/>
              </a:ext>
            </a:extLst>
          </p:cNvPr>
          <p:cNvSpPr/>
          <p:nvPr/>
        </p:nvSpPr>
        <p:spPr>
          <a:xfrm>
            <a:off x="1339092" y="670466"/>
            <a:ext cx="1614196" cy="28554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DE" sz="1800" b="0" i="0" u="none" strike="noStrike" kern="1200" cap="none" spc="0" normalizeH="0" baseline="0" noProof="0">
              <a:ln>
                <a:noFill/>
              </a:ln>
              <a:solidFill>
                <a:prstClr val="white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40A78AF7-EBAC-459D-8F3D-450BD1274429}"/>
              </a:ext>
            </a:extLst>
          </p:cNvPr>
          <p:cNvSpPr txBox="1"/>
          <p:nvPr/>
        </p:nvSpPr>
        <p:spPr>
          <a:xfrm>
            <a:off x="1703220" y="3823865"/>
            <a:ext cx="63145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relspec</a:t>
            </a:r>
            <a:endParaRPr kumimoji="0" lang="en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CFA1E9CD-70A2-426F-8915-7BE62773FB0F}"/>
              </a:ext>
            </a:extLst>
          </p:cNvPr>
          <p:cNvSpPr txBox="1"/>
          <p:nvPr/>
        </p:nvSpPr>
        <p:spPr>
          <a:xfrm rot="16200000">
            <a:off x="2425738" y="2389815"/>
            <a:ext cx="2386585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>
                <a:solidFill>
                  <a:prstClr val="black"/>
                </a:solidFill>
                <a:latin typeface="Calibri" panose="020F0502020204030204"/>
              </a:rPr>
              <a:t>r</a:t>
            </a:r>
            <a:r>
              <a:rPr kumimoji="0" lang="en-US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lspec</a:t>
            </a:r>
            <a:endParaRPr kumimoji="0" lang="en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90717EF0-7758-480B-9039-D5BC03618CEA}"/>
              </a:ext>
            </a:extLst>
          </p:cNvPr>
          <p:cNvCxnSpPr/>
          <p:nvPr/>
        </p:nvCxnSpPr>
        <p:spPr>
          <a:xfrm>
            <a:off x="2860952" y="1603183"/>
            <a:ext cx="0" cy="1922107"/>
          </a:xfrm>
          <a:prstGeom prst="line">
            <a:avLst/>
          </a:prstGeom>
          <a:ln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6">
            <a:extLst>
              <a:ext uri="{FF2B5EF4-FFF2-40B4-BE49-F238E27FC236}">
                <a16:creationId xmlns:a16="http://schemas.microsoft.com/office/drawing/2014/main" id="{8AFCC5FC-7B87-4B3C-8371-1C30984F4D4C}"/>
              </a:ext>
            </a:extLst>
          </p:cNvPr>
          <p:cNvSpPr txBox="1"/>
          <p:nvPr/>
        </p:nvSpPr>
        <p:spPr>
          <a:xfrm>
            <a:off x="7426091" y="1677682"/>
            <a:ext cx="63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p 1%</a:t>
            </a:r>
            <a:endParaRPr kumimoji="0" lang="en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6ADD6F8D-BA3C-4FCB-B467-126EEE6049B5}"/>
              </a:ext>
            </a:extLst>
          </p:cNvPr>
          <p:cNvSpPr txBox="1"/>
          <p:nvPr/>
        </p:nvSpPr>
        <p:spPr>
          <a:xfrm>
            <a:off x="2831494" y="3100196"/>
            <a:ext cx="6326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Top 1%</a:t>
            </a:r>
            <a:endParaRPr kumimoji="0" lang="en-DE" sz="12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 panose="020F0502020204030204"/>
              <a:ea typeface="+mn-ea"/>
              <a:cs typeface="+mn-cs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D1FA628E-5A13-43C6-8F70-483C6FD73449}"/>
              </a:ext>
            </a:extLst>
          </p:cNvPr>
          <p:cNvSpPr txBox="1"/>
          <p:nvPr/>
        </p:nvSpPr>
        <p:spPr>
          <a:xfrm>
            <a:off x="712284" y="5217466"/>
            <a:ext cx="1076743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1. </a:t>
            </a:r>
            <a:r>
              <a:rPr lang="en-US" sz="1200" dirty="0"/>
              <a:t>A) Distribution of the parameter </a:t>
            </a:r>
            <a:r>
              <a:rPr lang="en-US" sz="1200" dirty="0" err="1"/>
              <a:t>relspec</a:t>
            </a:r>
            <a:r>
              <a:rPr lang="en-US" sz="1200" dirty="0"/>
              <a:t> of all 25kb windows on the A-</a:t>
            </a:r>
            <a:r>
              <a:rPr lang="en-US" sz="1200" dirty="0" err="1"/>
              <a:t>chr</a:t>
            </a:r>
            <a:r>
              <a:rPr lang="en-US" sz="1200" dirty="0"/>
              <a:t> (see methods) and B) Manhattan plot of </a:t>
            </a:r>
            <a:r>
              <a:rPr lang="en-US" sz="1200" dirty="0" err="1"/>
              <a:t>relspec</a:t>
            </a:r>
            <a:r>
              <a:rPr lang="en-US" sz="1200" dirty="0"/>
              <a:t> across all A-</a:t>
            </a:r>
            <a:r>
              <a:rPr lang="en-US" sz="1200" dirty="0" err="1"/>
              <a:t>chr</a:t>
            </a:r>
            <a:r>
              <a:rPr lang="en-US" sz="1200" dirty="0"/>
              <a:t> contigs used to identify potential GRC regions. The top 1% threshold is indicated.</a:t>
            </a:r>
            <a:endParaRPr lang="en-DE" sz="1200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E36A667F-060E-409A-B9F0-EA770FB447DB}"/>
              </a:ext>
            </a:extLst>
          </p:cNvPr>
          <p:cNvSpPr txBox="1"/>
          <p:nvPr/>
        </p:nvSpPr>
        <p:spPr>
          <a:xfrm>
            <a:off x="164592" y="3657600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  <a:endParaRPr lang="en-DE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F8E61991-5180-4924-BA99-9CC6C58C1E0E}"/>
              </a:ext>
            </a:extLst>
          </p:cNvPr>
          <p:cNvSpPr txBox="1"/>
          <p:nvPr/>
        </p:nvSpPr>
        <p:spPr>
          <a:xfrm>
            <a:off x="3611880" y="3635018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)</a:t>
            </a:r>
            <a:endParaRPr lang="en-DE" dirty="0"/>
          </a:p>
        </p:txBody>
      </p:sp>
    </p:spTree>
    <p:extLst>
      <p:ext uri="{BB962C8B-B14F-4D97-AF65-F5344CB8AC3E}">
        <p14:creationId xmlns:p14="http://schemas.microsoft.com/office/powerpoint/2010/main" val="12591037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>
            <a:extLst>
              <a:ext uri="{FF2B5EF4-FFF2-40B4-BE49-F238E27FC236}">
                <a16:creationId xmlns:a16="http://schemas.microsoft.com/office/drawing/2014/main" id="{56335D9D-C2F1-4F7D-8CF6-67C7A8313CB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49553" y="3319867"/>
            <a:ext cx="7893510" cy="2650569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E1989070-A353-4EC6-9C1E-5E1E7D2C932E}"/>
              </a:ext>
            </a:extLst>
          </p:cNvPr>
          <p:cNvSpPr txBox="1"/>
          <p:nvPr/>
        </p:nvSpPr>
        <p:spPr>
          <a:xfrm>
            <a:off x="1120420" y="6214809"/>
            <a:ext cx="997125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2. </a:t>
            </a:r>
            <a:r>
              <a:rPr lang="en-US" sz="1200" dirty="0"/>
              <a:t>A) Distribution of estimated copy number of all 25kb windows on the GRC and B) Manhattan plot of copy number across all GRC contigs.</a:t>
            </a:r>
            <a:endParaRPr lang="en-DE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3C3199E-B195-4DD2-8372-B85D4DD6918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591396" y="22482"/>
            <a:ext cx="7721416" cy="349795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3E76766C-5059-4CB7-BEA6-DF885ACB3953}"/>
              </a:ext>
            </a:extLst>
          </p:cNvPr>
          <p:cNvSpPr txBox="1"/>
          <p:nvPr/>
        </p:nvSpPr>
        <p:spPr>
          <a:xfrm>
            <a:off x="1573107" y="2787902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  <a:endParaRPr lang="en-DE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6882AFA2-97DF-4F0C-9A97-28BF2BB2F993}"/>
              </a:ext>
            </a:extLst>
          </p:cNvPr>
          <p:cNvSpPr txBox="1"/>
          <p:nvPr/>
        </p:nvSpPr>
        <p:spPr>
          <a:xfrm>
            <a:off x="1605844" y="5534715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)</a:t>
            </a:r>
            <a:endParaRPr lang="en-DE" dirty="0"/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10B5533F-71A4-4523-94BD-0D5DA29D88C8}"/>
              </a:ext>
            </a:extLst>
          </p:cNvPr>
          <p:cNvSpPr/>
          <p:nvPr/>
        </p:nvSpPr>
        <p:spPr>
          <a:xfrm>
            <a:off x="4572000" y="242937"/>
            <a:ext cx="1984248" cy="25964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62881D4F-4EA0-4DC1-8193-E1A91BB6B791}"/>
              </a:ext>
            </a:extLst>
          </p:cNvPr>
          <p:cNvSpPr txBox="1"/>
          <p:nvPr/>
        </p:nvSpPr>
        <p:spPr>
          <a:xfrm>
            <a:off x="5151683" y="3053439"/>
            <a:ext cx="102547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Copy number</a:t>
            </a:r>
            <a:endParaRPr lang="en-DE" sz="1200" dirty="0"/>
          </a:p>
        </p:txBody>
      </p:sp>
    </p:spTree>
    <p:extLst>
      <p:ext uri="{BB962C8B-B14F-4D97-AF65-F5344CB8AC3E}">
        <p14:creationId xmlns:p14="http://schemas.microsoft.com/office/powerpoint/2010/main" val="2268271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900DBAF9-DDA1-4830-9ECD-BC8A7754F24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9665" y="677691"/>
            <a:ext cx="7992590" cy="427732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E756C981-62EA-4CB9-83E4-FBF634442466}"/>
              </a:ext>
            </a:extLst>
          </p:cNvPr>
          <p:cNvSpPr txBox="1"/>
          <p:nvPr/>
        </p:nvSpPr>
        <p:spPr>
          <a:xfrm>
            <a:off x="1249247" y="5907697"/>
            <a:ext cx="956462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3. </a:t>
            </a:r>
            <a:r>
              <a:rPr lang="en-US" sz="1200" dirty="0"/>
              <a:t>Difference between the median number of isoforms in GRC genes as represented by the 83 shared gene symbols and A-</a:t>
            </a:r>
            <a:r>
              <a:rPr lang="en-US" sz="1200" dirty="0" err="1"/>
              <a:t>chr</a:t>
            </a:r>
            <a:r>
              <a:rPr lang="en-US" sz="1200" dirty="0"/>
              <a:t> paralogs </a:t>
            </a:r>
            <a:endParaRPr lang="en-DE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9FD8736-44B3-45E1-B962-4136A7E05A14}"/>
              </a:ext>
            </a:extLst>
          </p:cNvPr>
          <p:cNvSpPr txBox="1"/>
          <p:nvPr/>
        </p:nvSpPr>
        <p:spPr>
          <a:xfrm>
            <a:off x="3344007" y="4407111"/>
            <a:ext cx="549656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edian # isoforms in GRC paralogs – median # isoforms in A-</a:t>
            </a:r>
            <a:r>
              <a:rPr lang="en-US" sz="1400" dirty="0" err="1"/>
              <a:t>chr</a:t>
            </a:r>
            <a:r>
              <a:rPr lang="en-US" sz="1400" dirty="0"/>
              <a:t> paralogs</a:t>
            </a:r>
            <a:endParaRPr lang="en-DE" sz="1400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FA267BE4-F665-4AAA-898C-B30AA5D3AF65}"/>
              </a:ext>
            </a:extLst>
          </p:cNvPr>
          <p:cNvSpPr/>
          <p:nvPr/>
        </p:nvSpPr>
        <p:spPr>
          <a:xfrm>
            <a:off x="4791456" y="850392"/>
            <a:ext cx="2788920" cy="4572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7228829D-0767-4419-9F13-9339DF95BE9E}"/>
              </a:ext>
            </a:extLst>
          </p:cNvPr>
          <p:cNvSpPr txBox="1"/>
          <p:nvPr/>
        </p:nvSpPr>
        <p:spPr>
          <a:xfrm>
            <a:off x="7050024" y="3648456"/>
            <a:ext cx="4844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PIM1</a:t>
            </a:r>
            <a:endParaRPr lang="en-DE" sz="1100" i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EA45788-47E9-4369-B36B-098276535BF1}"/>
              </a:ext>
            </a:extLst>
          </p:cNvPr>
          <p:cNvSpPr txBox="1"/>
          <p:nvPr/>
        </p:nvSpPr>
        <p:spPr>
          <a:xfrm>
            <a:off x="7339584" y="3563112"/>
            <a:ext cx="4844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PAK1</a:t>
            </a:r>
            <a:endParaRPr lang="en-DE" sz="1100" i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10EEBDD-B402-44DA-AB99-402558E224F0}"/>
              </a:ext>
            </a:extLst>
          </p:cNvPr>
          <p:cNvSpPr txBox="1"/>
          <p:nvPr/>
        </p:nvSpPr>
        <p:spPr>
          <a:xfrm>
            <a:off x="8854440" y="3614928"/>
            <a:ext cx="6351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MROH1</a:t>
            </a:r>
            <a:endParaRPr lang="en-DE" sz="1100" i="1" dirty="0"/>
          </a:p>
        </p:txBody>
      </p:sp>
    </p:spTree>
    <p:extLst>
      <p:ext uri="{BB962C8B-B14F-4D97-AF65-F5344CB8AC3E}">
        <p14:creationId xmlns:p14="http://schemas.microsoft.com/office/powerpoint/2010/main" val="305994341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D1F6A47-4895-491B-ABFE-652D6AA4224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21561" y="695979"/>
            <a:ext cx="8183117" cy="427732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379A078-5798-444C-AD7B-CAE2F3EB872C}"/>
              </a:ext>
            </a:extLst>
          </p:cNvPr>
          <p:cNvSpPr txBox="1"/>
          <p:nvPr/>
        </p:nvSpPr>
        <p:spPr>
          <a:xfrm>
            <a:off x="1441704" y="5869108"/>
            <a:ext cx="930859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4. </a:t>
            </a:r>
            <a:r>
              <a:rPr lang="en-US" sz="1200" dirty="0"/>
              <a:t>Difference between the median isoform length in GRC genes as represented by the 83 shared gene symbols and A-</a:t>
            </a:r>
            <a:r>
              <a:rPr lang="en-US" sz="1200" dirty="0" err="1"/>
              <a:t>chr</a:t>
            </a:r>
            <a:r>
              <a:rPr lang="en-US" sz="1200" dirty="0"/>
              <a:t> paralogs </a:t>
            </a:r>
            <a:endParaRPr lang="en-DE" sz="1200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9798A40-136E-448E-A9C4-9837D9D50315}"/>
              </a:ext>
            </a:extLst>
          </p:cNvPr>
          <p:cNvSpPr txBox="1"/>
          <p:nvPr/>
        </p:nvSpPr>
        <p:spPr>
          <a:xfrm>
            <a:off x="2688336" y="4448259"/>
            <a:ext cx="6103530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edian isoform length in GRC paralogs – median isoform length in A-</a:t>
            </a:r>
            <a:r>
              <a:rPr lang="en-US" sz="1400" dirty="0" err="1"/>
              <a:t>chr</a:t>
            </a:r>
            <a:r>
              <a:rPr lang="en-US" sz="1400" dirty="0"/>
              <a:t> paralogs</a:t>
            </a:r>
            <a:endParaRPr lang="en-DE" sz="1400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067FE646-E131-4584-BB1D-6FAD71FFB33F}"/>
              </a:ext>
            </a:extLst>
          </p:cNvPr>
          <p:cNvSpPr/>
          <p:nvPr/>
        </p:nvSpPr>
        <p:spPr>
          <a:xfrm>
            <a:off x="4791456" y="850392"/>
            <a:ext cx="2788920" cy="4572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197C676-8622-4F8C-9DFA-E5C73CF7D664}"/>
              </a:ext>
            </a:extLst>
          </p:cNvPr>
          <p:cNvSpPr txBox="1"/>
          <p:nvPr/>
        </p:nvSpPr>
        <p:spPr>
          <a:xfrm>
            <a:off x="8013192" y="3596640"/>
            <a:ext cx="6351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MROH1</a:t>
            </a:r>
            <a:endParaRPr lang="en-DE" sz="1100" i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6DDA04F-0B9B-4A2F-9AF5-5164E2E320EB}"/>
              </a:ext>
            </a:extLst>
          </p:cNvPr>
          <p:cNvSpPr txBox="1"/>
          <p:nvPr/>
        </p:nvSpPr>
        <p:spPr>
          <a:xfrm>
            <a:off x="8311896" y="3483864"/>
            <a:ext cx="48442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PAK1</a:t>
            </a:r>
            <a:endParaRPr lang="en-DE" sz="1100" i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669F03B-4D32-4F0A-8F2E-2F6B996B2361}"/>
              </a:ext>
            </a:extLst>
          </p:cNvPr>
          <p:cNvSpPr txBox="1"/>
          <p:nvPr/>
        </p:nvSpPr>
        <p:spPr>
          <a:xfrm>
            <a:off x="8354568" y="3371088"/>
            <a:ext cx="89319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ERVPABLB-1</a:t>
            </a:r>
            <a:endParaRPr lang="en-DE" sz="1100" i="1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458E5F5-E500-4CA3-99A6-7A3259E0B919}"/>
              </a:ext>
            </a:extLst>
          </p:cNvPr>
          <p:cNvSpPr txBox="1"/>
          <p:nvPr/>
        </p:nvSpPr>
        <p:spPr>
          <a:xfrm>
            <a:off x="8982456" y="3587496"/>
            <a:ext cx="787395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HLA-DQB1</a:t>
            </a:r>
            <a:endParaRPr lang="en-DE" sz="1100" i="1" dirty="0"/>
          </a:p>
        </p:txBody>
      </p:sp>
    </p:spTree>
    <p:extLst>
      <p:ext uri="{BB962C8B-B14F-4D97-AF65-F5344CB8AC3E}">
        <p14:creationId xmlns:p14="http://schemas.microsoft.com/office/powerpoint/2010/main" val="16373808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>
            <a:extLst>
              <a:ext uri="{FF2B5EF4-FFF2-40B4-BE49-F238E27FC236}">
                <a16:creationId xmlns:a16="http://schemas.microsoft.com/office/drawing/2014/main" id="{CE5B08F7-F5BD-46E3-BEAB-7A30CD390854}"/>
              </a:ext>
            </a:extLst>
          </p:cNvPr>
          <p:cNvSpPr/>
          <p:nvPr/>
        </p:nvSpPr>
        <p:spPr>
          <a:xfrm>
            <a:off x="527926" y="259097"/>
            <a:ext cx="4238507" cy="503052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31" name="Rectangle 30">
            <a:extLst>
              <a:ext uri="{FF2B5EF4-FFF2-40B4-BE49-F238E27FC236}">
                <a16:creationId xmlns:a16="http://schemas.microsoft.com/office/drawing/2014/main" id="{2F7A736C-08BA-4553-8EC3-A79F1947F1DC}"/>
              </a:ext>
            </a:extLst>
          </p:cNvPr>
          <p:cNvSpPr/>
          <p:nvPr/>
        </p:nvSpPr>
        <p:spPr>
          <a:xfrm>
            <a:off x="6079948" y="3655290"/>
            <a:ext cx="4030825" cy="26066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BC20C47-5D05-4738-867A-244062DEC719}"/>
              </a:ext>
            </a:extLst>
          </p:cNvPr>
          <p:cNvSpPr txBox="1"/>
          <p:nvPr/>
        </p:nvSpPr>
        <p:spPr>
          <a:xfrm>
            <a:off x="794716" y="5796261"/>
            <a:ext cx="1057046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5. </a:t>
            </a:r>
            <a:r>
              <a:rPr lang="en-US" sz="1200" dirty="0"/>
              <a:t>Difference between the median fraction of </a:t>
            </a:r>
            <a:r>
              <a:rPr lang="en-US" sz="1200" dirty="0" err="1"/>
              <a:t>UniProtKB</a:t>
            </a:r>
            <a:r>
              <a:rPr lang="en-US" sz="1200" dirty="0"/>
              <a:t> reference gene in GRC genes as represented by the 83 shared gene symbols and A-</a:t>
            </a:r>
            <a:r>
              <a:rPr lang="en-US" sz="1200" dirty="0" err="1"/>
              <a:t>chr</a:t>
            </a:r>
            <a:r>
              <a:rPr lang="en-US" sz="1200" dirty="0"/>
              <a:t> paralogs </a:t>
            </a:r>
            <a:endParaRPr lang="en-DE" sz="1200" dirty="0"/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5E6609A-1099-4402-BC42-6FFD3774E882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07491" y="625749"/>
            <a:ext cx="7472310" cy="433944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633D031D-DCED-4153-B1ED-EA974D344D31}"/>
              </a:ext>
            </a:extLst>
          </p:cNvPr>
          <p:cNvSpPr txBox="1"/>
          <p:nvPr/>
        </p:nvSpPr>
        <p:spPr>
          <a:xfrm>
            <a:off x="2278478" y="4408187"/>
            <a:ext cx="705039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dirty="0"/>
              <a:t>Median fraction of </a:t>
            </a:r>
            <a:r>
              <a:rPr lang="en-US" sz="1400" dirty="0" err="1"/>
              <a:t>UniProtKB</a:t>
            </a:r>
            <a:r>
              <a:rPr lang="en-US" sz="1400" dirty="0"/>
              <a:t> ref gene in GRC – median fraction of </a:t>
            </a:r>
            <a:r>
              <a:rPr lang="en-US" sz="1400" dirty="0" err="1"/>
              <a:t>UniProtKB</a:t>
            </a:r>
            <a:r>
              <a:rPr lang="en-US" sz="1400" dirty="0"/>
              <a:t> ref gene in A-</a:t>
            </a:r>
            <a:r>
              <a:rPr lang="en-US" sz="1400" dirty="0" err="1"/>
              <a:t>chr</a:t>
            </a:r>
            <a:endParaRPr lang="en-DE" sz="1400" dirty="0"/>
          </a:p>
        </p:txBody>
      </p:sp>
      <p:sp>
        <p:nvSpPr>
          <p:cNvPr id="21" name="Rectangle 20">
            <a:extLst>
              <a:ext uri="{FF2B5EF4-FFF2-40B4-BE49-F238E27FC236}">
                <a16:creationId xmlns:a16="http://schemas.microsoft.com/office/drawing/2014/main" id="{E12C1E2A-89F6-4052-B40D-69282AF5300A}"/>
              </a:ext>
            </a:extLst>
          </p:cNvPr>
          <p:cNvSpPr/>
          <p:nvPr/>
        </p:nvSpPr>
        <p:spPr>
          <a:xfrm>
            <a:off x="4498848" y="813816"/>
            <a:ext cx="2788920" cy="45720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25AA72BC-4B8C-4F1F-95C5-63ECAE2158D3}"/>
              </a:ext>
            </a:extLst>
          </p:cNvPr>
          <p:cNvSpPr txBox="1"/>
          <p:nvPr/>
        </p:nvSpPr>
        <p:spPr>
          <a:xfrm>
            <a:off x="7940040" y="3511636"/>
            <a:ext cx="122982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KIAA1466=ERV3-2</a:t>
            </a:r>
            <a:endParaRPr lang="en-DE" sz="1100" i="1" dirty="0"/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ED4805B-806A-4E31-A471-51285F36336A}"/>
              </a:ext>
            </a:extLst>
          </p:cNvPr>
          <p:cNvSpPr txBox="1"/>
          <p:nvPr/>
        </p:nvSpPr>
        <p:spPr>
          <a:xfrm>
            <a:off x="7470648" y="3417148"/>
            <a:ext cx="62228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ZNF513</a:t>
            </a:r>
            <a:endParaRPr lang="en-DE" sz="1100" i="1" dirty="0"/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9005081A-8C40-4BE6-83CD-15F8F4A1EB90}"/>
              </a:ext>
            </a:extLst>
          </p:cNvPr>
          <p:cNvSpPr txBox="1"/>
          <p:nvPr/>
        </p:nvSpPr>
        <p:spPr>
          <a:xfrm>
            <a:off x="7177793" y="3313775"/>
            <a:ext cx="63511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MROH1</a:t>
            </a:r>
            <a:endParaRPr lang="en-DE" sz="1100" i="1" dirty="0"/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E919F335-6411-40AF-93AC-2C2D0B475C74}"/>
              </a:ext>
            </a:extLst>
          </p:cNvPr>
          <p:cNvSpPr txBox="1"/>
          <p:nvPr/>
        </p:nvSpPr>
        <p:spPr>
          <a:xfrm>
            <a:off x="6872407" y="3199356"/>
            <a:ext cx="598241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i="1" dirty="0"/>
              <a:t>BMP15</a:t>
            </a:r>
            <a:endParaRPr lang="en-DE" sz="1100" i="1" dirty="0"/>
          </a:p>
        </p:txBody>
      </p:sp>
      <p:cxnSp>
        <p:nvCxnSpPr>
          <p:cNvPr id="8" name="Straight Arrow Connector 7">
            <a:extLst>
              <a:ext uri="{FF2B5EF4-FFF2-40B4-BE49-F238E27FC236}">
                <a16:creationId xmlns:a16="http://schemas.microsoft.com/office/drawing/2014/main" id="{80C60BBA-BD7A-4B40-92EB-4DF414EF8D98}"/>
              </a:ext>
            </a:extLst>
          </p:cNvPr>
          <p:cNvCxnSpPr>
            <a:cxnSpLocks/>
          </p:cNvCxnSpPr>
          <p:nvPr/>
        </p:nvCxnSpPr>
        <p:spPr>
          <a:xfrm flipH="1">
            <a:off x="7103533" y="3442678"/>
            <a:ext cx="49707" cy="249832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4976776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>
            <a:extLst>
              <a:ext uri="{FF2B5EF4-FFF2-40B4-BE49-F238E27FC236}">
                <a16:creationId xmlns:a16="http://schemas.microsoft.com/office/drawing/2014/main" id="{07700FA1-89D2-4029-A37D-205240E224D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7189" y="3272907"/>
            <a:ext cx="8477889" cy="3019779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123A0AF8-5D30-4097-9CAB-27FFFA5B9F19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7189" y="10760"/>
            <a:ext cx="8642679" cy="3102173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06DAF4F3-120C-4089-BE4D-20EA4DA0A639}"/>
              </a:ext>
            </a:extLst>
          </p:cNvPr>
          <p:cNvSpPr txBox="1"/>
          <p:nvPr/>
        </p:nvSpPr>
        <p:spPr>
          <a:xfrm>
            <a:off x="304416" y="6441682"/>
            <a:ext cx="115831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6</a:t>
            </a:r>
            <a:r>
              <a:rPr lang="en-US" sz="1200" dirty="0"/>
              <a:t>. A) Boxplot of exon lengths for each exon number separated for GRC genes and A-</a:t>
            </a:r>
            <a:r>
              <a:rPr lang="en-US" sz="1200" dirty="0" err="1"/>
              <a:t>chr</a:t>
            </a:r>
            <a:r>
              <a:rPr lang="en-US" sz="1200" dirty="0"/>
              <a:t> paralogs and B) same for introns. Sample sizes for each boxplot are given on top.</a:t>
            </a:r>
            <a:endParaRPr lang="en-DE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09BCD433-88CC-427C-9949-D70BE223F3B3}"/>
              </a:ext>
            </a:extLst>
          </p:cNvPr>
          <p:cNvSpPr txBox="1"/>
          <p:nvPr/>
        </p:nvSpPr>
        <p:spPr>
          <a:xfrm>
            <a:off x="1123065" y="2703254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  <a:endParaRPr lang="en-DE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B0EF118-ADAB-413D-87C6-2412058D0D62}"/>
              </a:ext>
            </a:extLst>
          </p:cNvPr>
          <p:cNvSpPr txBox="1"/>
          <p:nvPr/>
        </p:nvSpPr>
        <p:spPr>
          <a:xfrm>
            <a:off x="1051849" y="5849332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)</a:t>
            </a:r>
            <a:endParaRPr lang="en-DE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C1A92EFF-E940-437B-85C4-6ABA26B21A67}"/>
              </a:ext>
            </a:extLst>
          </p:cNvPr>
          <p:cNvSpPr txBox="1"/>
          <p:nvPr/>
        </p:nvSpPr>
        <p:spPr>
          <a:xfrm>
            <a:off x="5049071" y="2947925"/>
            <a:ext cx="1014124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Exon number</a:t>
            </a:r>
            <a:endParaRPr lang="en-DE" sz="12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4A6BAAF-07C9-4A1E-A2D5-DDDDF8DAEE52}"/>
              </a:ext>
            </a:extLst>
          </p:cNvPr>
          <p:cNvSpPr txBox="1"/>
          <p:nvPr/>
        </p:nvSpPr>
        <p:spPr>
          <a:xfrm>
            <a:off x="4925568" y="6125513"/>
            <a:ext cx="1094467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Intron number</a:t>
            </a:r>
            <a:endParaRPr lang="en-DE" sz="12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0C8CDA5-4292-4C2A-A0ED-D9DDB1A4F526}"/>
              </a:ext>
            </a:extLst>
          </p:cNvPr>
          <p:cNvSpPr txBox="1"/>
          <p:nvPr/>
        </p:nvSpPr>
        <p:spPr>
          <a:xfrm>
            <a:off x="9713982" y="1310245"/>
            <a:ext cx="492443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/>
              <a:t>A-</a:t>
            </a:r>
            <a:r>
              <a:rPr lang="en-US" sz="1100" dirty="0" err="1"/>
              <a:t>chr</a:t>
            </a:r>
            <a:endParaRPr lang="en-US" sz="1100" dirty="0"/>
          </a:p>
          <a:p>
            <a:r>
              <a:rPr lang="en-US" sz="1100" dirty="0"/>
              <a:t>GRC</a:t>
            </a:r>
            <a:endParaRPr lang="en-DE" sz="1100" dirty="0"/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CE2513BC-CEFC-4E0D-9647-1DFA55558605}"/>
              </a:ext>
            </a:extLst>
          </p:cNvPr>
          <p:cNvSpPr txBox="1"/>
          <p:nvPr/>
        </p:nvSpPr>
        <p:spPr>
          <a:xfrm>
            <a:off x="9548856" y="4517920"/>
            <a:ext cx="492443" cy="43088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100" dirty="0"/>
              <a:t>A-</a:t>
            </a:r>
            <a:r>
              <a:rPr lang="en-US" sz="1100" dirty="0" err="1"/>
              <a:t>chr</a:t>
            </a:r>
            <a:endParaRPr lang="en-US" sz="1100" dirty="0"/>
          </a:p>
          <a:p>
            <a:r>
              <a:rPr lang="en-US" sz="1100" dirty="0"/>
              <a:t>GRC</a:t>
            </a:r>
            <a:endParaRPr lang="en-DE" sz="1100" dirty="0"/>
          </a:p>
        </p:txBody>
      </p:sp>
      <p:sp>
        <p:nvSpPr>
          <p:cNvPr id="2" name="Rectangle 1">
            <a:extLst>
              <a:ext uri="{FF2B5EF4-FFF2-40B4-BE49-F238E27FC236}">
                <a16:creationId xmlns:a16="http://schemas.microsoft.com/office/drawing/2014/main" id="{03150C2A-7035-4ED0-B42F-DADA588C157B}"/>
              </a:ext>
            </a:extLst>
          </p:cNvPr>
          <p:cNvSpPr/>
          <p:nvPr/>
        </p:nvSpPr>
        <p:spPr>
          <a:xfrm>
            <a:off x="9527703" y="1198254"/>
            <a:ext cx="234792" cy="1330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7" name="Rectangle 16">
            <a:extLst>
              <a:ext uri="{FF2B5EF4-FFF2-40B4-BE49-F238E27FC236}">
                <a16:creationId xmlns:a16="http://schemas.microsoft.com/office/drawing/2014/main" id="{E9AD8BB7-AAAC-478E-A55A-B5654104B48C}"/>
              </a:ext>
            </a:extLst>
          </p:cNvPr>
          <p:cNvSpPr/>
          <p:nvPr/>
        </p:nvSpPr>
        <p:spPr>
          <a:xfrm>
            <a:off x="9382875" y="4437020"/>
            <a:ext cx="234792" cy="133074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4" name="Rectangle 3">
            <a:extLst>
              <a:ext uri="{FF2B5EF4-FFF2-40B4-BE49-F238E27FC236}">
                <a16:creationId xmlns:a16="http://schemas.microsoft.com/office/drawing/2014/main" id="{89769B4F-80FF-4794-9370-E1877CBA0694}"/>
              </a:ext>
            </a:extLst>
          </p:cNvPr>
          <p:cNvSpPr/>
          <p:nvPr/>
        </p:nvSpPr>
        <p:spPr>
          <a:xfrm>
            <a:off x="8586216" y="36576"/>
            <a:ext cx="895056" cy="291134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A809C130-CE4C-4476-BD64-E50AF9D6FEC6}"/>
              </a:ext>
            </a:extLst>
          </p:cNvPr>
          <p:cNvSpPr txBox="1"/>
          <p:nvPr/>
        </p:nvSpPr>
        <p:spPr>
          <a:xfrm>
            <a:off x="8564772" y="27432"/>
            <a:ext cx="4267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</a:t>
            </a:r>
            <a:r>
              <a:rPr lang="en-US" sz="900" baseline="-25000" dirty="0"/>
              <a:t>A-</a:t>
            </a:r>
            <a:r>
              <a:rPr lang="en-US" sz="900" baseline="-25000" dirty="0" err="1"/>
              <a:t>chr</a:t>
            </a:r>
            <a:endParaRPr lang="en-US" sz="900" baseline="-25000" dirty="0"/>
          </a:p>
          <a:p>
            <a:pPr lvl="0"/>
            <a:r>
              <a:rPr lang="en-US" sz="900" dirty="0">
                <a:solidFill>
                  <a:prstClr val="black"/>
                </a:solidFill>
              </a:rPr>
              <a:t>N</a:t>
            </a:r>
            <a:r>
              <a:rPr lang="en-US" sz="900" baseline="-25000" dirty="0">
                <a:solidFill>
                  <a:prstClr val="black"/>
                </a:solidFill>
              </a:rPr>
              <a:t>GRC</a:t>
            </a:r>
          </a:p>
        </p:txBody>
      </p:sp>
      <p:sp>
        <p:nvSpPr>
          <p:cNvPr id="5" name="Rectangle 4">
            <a:extLst>
              <a:ext uri="{FF2B5EF4-FFF2-40B4-BE49-F238E27FC236}">
                <a16:creationId xmlns:a16="http://schemas.microsoft.com/office/drawing/2014/main" id="{5B497FC5-B5DD-4BC2-B843-8429B6942CD0}"/>
              </a:ext>
            </a:extLst>
          </p:cNvPr>
          <p:cNvSpPr/>
          <p:nvPr/>
        </p:nvSpPr>
        <p:spPr>
          <a:xfrm>
            <a:off x="8403336" y="3272907"/>
            <a:ext cx="945660" cy="294575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68F1B877-AB43-481B-9B5B-EEEA0CF49348}"/>
              </a:ext>
            </a:extLst>
          </p:cNvPr>
          <p:cNvSpPr txBox="1"/>
          <p:nvPr/>
        </p:nvSpPr>
        <p:spPr>
          <a:xfrm>
            <a:off x="8354682" y="3304603"/>
            <a:ext cx="42672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N</a:t>
            </a:r>
            <a:r>
              <a:rPr lang="en-US" sz="900" baseline="-25000" dirty="0"/>
              <a:t>A-</a:t>
            </a:r>
            <a:r>
              <a:rPr lang="en-US" sz="900" baseline="-25000" dirty="0" err="1"/>
              <a:t>chr</a:t>
            </a:r>
            <a:endParaRPr lang="en-US" sz="900" baseline="-25000" dirty="0"/>
          </a:p>
          <a:p>
            <a:pPr lvl="0"/>
            <a:r>
              <a:rPr lang="en-US" sz="900" dirty="0">
                <a:solidFill>
                  <a:prstClr val="black"/>
                </a:solidFill>
              </a:rPr>
              <a:t>N</a:t>
            </a:r>
            <a:r>
              <a:rPr lang="en-US" sz="900" baseline="-25000" dirty="0">
                <a:solidFill>
                  <a:prstClr val="black"/>
                </a:solidFill>
              </a:rPr>
              <a:t>GRC</a:t>
            </a:r>
          </a:p>
        </p:txBody>
      </p:sp>
    </p:spTree>
    <p:extLst>
      <p:ext uri="{BB962C8B-B14F-4D97-AF65-F5344CB8AC3E}">
        <p14:creationId xmlns:p14="http://schemas.microsoft.com/office/powerpoint/2010/main" val="407303016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C96D9B61-9E1C-4146-B3AC-FE84E8D069F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277948" y="485793"/>
            <a:ext cx="4547064" cy="3314682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8B66267-071C-47C1-AF00-FAE4D148025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44538" y="416290"/>
            <a:ext cx="4547064" cy="3384185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579160DA-ABFB-425A-BF3E-9A90D8402A79}"/>
              </a:ext>
            </a:extLst>
          </p:cNvPr>
          <p:cNvSpPr txBox="1"/>
          <p:nvPr/>
        </p:nvSpPr>
        <p:spPr>
          <a:xfrm>
            <a:off x="304416" y="4686282"/>
            <a:ext cx="11583168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/>
              <a:t>Suppl. Figure 7</a:t>
            </a:r>
            <a:r>
              <a:rPr lang="en-US" sz="1200" dirty="0"/>
              <a:t>. A) Histogram of testis-specific k-</a:t>
            </a:r>
            <a:r>
              <a:rPr lang="en-US" sz="1200" dirty="0" err="1"/>
              <a:t>mer</a:t>
            </a:r>
            <a:r>
              <a:rPr lang="en-US" sz="1200" dirty="0"/>
              <a:t> proportions per testis read. B) Density plot of tandem repeat proportions per testis read for different approaches: in blue the 8541 reads with germline-specific variants (this study), in orange the 11963 reads with a ratio of more than 0.1 testis-specific k-</a:t>
            </a:r>
            <a:r>
              <a:rPr lang="en-US" sz="1200" dirty="0" err="1"/>
              <a:t>mers</a:t>
            </a:r>
            <a:r>
              <a:rPr lang="en-US" sz="1200" dirty="0"/>
              <a:t>, and in red the 7643 reads with a ratio of more than 0.3 testis-specific k-</a:t>
            </a:r>
            <a:r>
              <a:rPr lang="en-US" sz="1200" dirty="0" err="1"/>
              <a:t>mers</a:t>
            </a:r>
            <a:r>
              <a:rPr lang="en-US" sz="1200" dirty="0"/>
              <a:t>.</a:t>
            </a:r>
          </a:p>
          <a:p>
            <a:r>
              <a:rPr lang="en-US" sz="1200" dirty="0"/>
              <a:t>Tandem repeats with alignment scores &gt; 300 were identified using tandem repeats finder (Benson G, 1999. Tandem repeats finder: a program to analyze DNA sequences. Nucleic Acids Res. 27:573–580).  </a:t>
            </a:r>
          </a:p>
          <a:p>
            <a:r>
              <a:rPr lang="en-US" sz="1200" dirty="0"/>
              <a:t>We identified all testis-specific k-</a:t>
            </a:r>
            <a:r>
              <a:rPr lang="en-US" sz="1200" dirty="0" err="1"/>
              <a:t>mers</a:t>
            </a:r>
            <a:r>
              <a:rPr lang="en-US" sz="1200" dirty="0"/>
              <a:t> of length 21 bases by comparing the k-</a:t>
            </a:r>
            <a:r>
              <a:rPr lang="en-US" sz="1200" dirty="0" err="1"/>
              <a:t>mer</a:t>
            </a:r>
            <a:r>
              <a:rPr lang="en-US" sz="1200" dirty="0"/>
              <a:t> databases of the long-read testis and soma sequences using </a:t>
            </a:r>
            <a:r>
              <a:rPr lang="en-US" sz="1200" dirty="0" err="1"/>
              <a:t>meryl</a:t>
            </a:r>
            <a:r>
              <a:rPr lang="en-US" sz="1200" dirty="0"/>
              <a:t> (Miller JR, et al. 2008. Aggressive assembly of pyrosequencing reads with mates. Bioinformatics 24:2818–24). We selected only k-</a:t>
            </a:r>
            <a:r>
              <a:rPr lang="en-US" sz="1200" dirty="0" err="1"/>
              <a:t>mers</a:t>
            </a:r>
            <a:r>
              <a:rPr lang="en-US" sz="1200" dirty="0"/>
              <a:t> with frequency &gt; 3 to account for potential sequencing errors. The ratio of testis-specific k-</a:t>
            </a:r>
            <a:r>
              <a:rPr lang="en-US" sz="1200" dirty="0" err="1"/>
              <a:t>mers</a:t>
            </a:r>
            <a:r>
              <a:rPr lang="en-US" sz="1200" dirty="0"/>
              <a:t> was calculated for each of the 5,387,360 testis reads using </a:t>
            </a:r>
            <a:r>
              <a:rPr lang="en-US" sz="1200" dirty="0" err="1"/>
              <a:t>meryl</a:t>
            </a:r>
            <a:r>
              <a:rPr lang="en-US" sz="1200" dirty="0"/>
              <a:t>-lookup. We applied two ratio thresholds (ratio 0.1 (orange) and ratio 0.3 (red)) to select potentially GRC-specific reads. </a:t>
            </a:r>
            <a:endParaRPr lang="en-DE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DEEC109-CA68-4298-93E3-E2C5C7EE7C5B}"/>
              </a:ext>
            </a:extLst>
          </p:cNvPr>
          <p:cNvSpPr txBox="1"/>
          <p:nvPr/>
        </p:nvSpPr>
        <p:spPr>
          <a:xfrm>
            <a:off x="1664956" y="540830"/>
            <a:ext cx="53251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5.4x10</a:t>
            </a:r>
            <a:r>
              <a:rPr lang="en-US" sz="900" baseline="30000" dirty="0"/>
              <a:t>6</a:t>
            </a:r>
            <a:endParaRPr lang="en-DE" sz="900" baseline="30000" dirty="0"/>
          </a:p>
        </p:txBody>
      </p:sp>
      <p:cxnSp>
        <p:nvCxnSpPr>
          <p:cNvPr id="16" name="Straight Arrow Connector 15">
            <a:extLst>
              <a:ext uri="{FF2B5EF4-FFF2-40B4-BE49-F238E27FC236}">
                <a16:creationId xmlns:a16="http://schemas.microsoft.com/office/drawing/2014/main" id="{C0104549-C0AB-400F-8364-0DF623276D80}"/>
              </a:ext>
            </a:extLst>
          </p:cNvPr>
          <p:cNvCxnSpPr>
            <a:cxnSpLocks/>
          </p:cNvCxnSpPr>
          <p:nvPr/>
        </p:nvCxnSpPr>
        <p:spPr>
          <a:xfrm flipV="1">
            <a:off x="1911350" y="718065"/>
            <a:ext cx="0" cy="222979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Rectangle 17">
            <a:extLst>
              <a:ext uri="{FF2B5EF4-FFF2-40B4-BE49-F238E27FC236}">
                <a16:creationId xmlns:a16="http://schemas.microsoft.com/office/drawing/2014/main" id="{4C804D2A-3876-4E86-AE15-45654EA245DA}"/>
              </a:ext>
            </a:extLst>
          </p:cNvPr>
          <p:cNvSpPr/>
          <p:nvPr/>
        </p:nvSpPr>
        <p:spPr>
          <a:xfrm>
            <a:off x="2800350" y="540830"/>
            <a:ext cx="1752594" cy="33547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9A2DB66-3478-475A-AFA7-33160729A16F}"/>
              </a:ext>
            </a:extLst>
          </p:cNvPr>
          <p:cNvSpPr txBox="1"/>
          <p:nvPr/>
        </p:nvSpPr>
        <p:spPr>
          <a:xfrm>
            <a:off x="2001506" y="3437493"/>
            <a:ext cx="2784673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Ratio testis-specific k-</a:t>
            </a:r>
            <a:r>
              <a:rPr lang="en-US" sz="1200" dirty="0" err="1"/>
              <a:t>mers</a:t>
            </a:r>
            <a:r>
              <a:rPr lang="en-US" sz="1200" dirty="0"/>
              <a:t> per testis read</a:t>
            </a:r>
            <a:endParaRPr lang="en-DE" sz="1200" dirty="0"/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083D758D-0293-4553-8E08-6242D0BE0FF4}"/>
              </a:ext>
            </a:extLst>
          </p:cNvPr>
          <p:cNvCxnSpPr>
            <a:cxnSpLocks/>
          </p:cNvCxnSpPr>
          <p:nvPr/>
        </p:nvCxnSpPr>
        <p:spPr>
          <a:xfrm>
            <a:off x="2266950" y="1898650"/>
            <a:ext cx="0" cy="1374775"/>
          </a:xfrm>
          <a:prstGeom prst="line">
            <a:avLst/>
          </a:prstGeom>
          <a:ln w="19050">
            <a:solidFill>
              <a:srgbClr val="FFC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Straight Connector 21">
            <a:extLst>
              <a:ext uri="{FF2B5EF4-FFF2-40B4-BE49-F238E27FC236}">
                <a16:creationId xmlns:a16="http://schemas.microsoft.com/office/drawing/2014/main" id="{1C34F621-6F95-4467-B9D3-A66C5323B943}"/>
              </a:ext>
            </a:extLst>
          </p:cNvPr>
          <p:cNvCxnSpPr>
            <a:cxnSpLocks/>
          </p:cNvCxnSpPr>
          <p:nvPr/>
        </p:nvCxnSpPr>
        <p:spPr>
          <a:xfrm>
            <a:off x="3003550" y="1898650"/>
            <a:ext cx="0" cy="1374775"/>
          </a:xfrm>
          <a:prstGeom prst="line">
            <a:avLst/>
          </a:prstGeom>
          <a:ln w="1905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24">
            <a:extLst>
              <a:ext uri="{FF2B5EF4-FFF2-40B4-BE49-F238E27FC236}">
                <a16:creationId xmlns:a16="http://schemas.microsoft.com/office/drawing/2014/main" id="{96F40400-35DE-42FB-A040-6F8139D3DAB5}"/>
              </a:ext>
            </a:extLst>
          </p:cNvPr>
          <p:cNvSpPr txBox="1"/>
          <p:nvPr/>
        </p:nvSpPr>
        <p:spPr>
          <a:xfrm>
            <a:off x="2108574" y="3263900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0.1</a:t>
            </a:r>
            <a:endParaRPr lang="en-DE" sz="900" dirty="0"/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8FFF0AC9-C58D-433A-99A6-8EA65DB16264}"/>
              </a:ext>
            </a:extLst>
          </p:cNvPr>
          <p:cNvSpPr txBox="1"/>
          <p:nvPr/>
        </p:nvSpPr>
        <p:spPr>
          <a:xfrm>
            <a:off x="2845174" y="3270250"/>
            <a:ext cx="32893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0.3</a:t>
            </a:r>
            <a:endParaRPr lang="en-DE" sz="900" dirty="0"/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F698F42C-7BC9-4E79-96E9-344B5BB3CBD8}"/>
              </a:ext>
            </a:extLst>
          </p:cNvPr>
          <p:cNvSpPr txBox="1"/>
          <p:nvPr/>
        </p:nvSpPr>
        <p:spPr>
          <a:xfrm>
            <a:off x="7575125" y="3401320"/>
            <a:ext cx="2559355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200" dirty="0"/>
              <a:t>Ratio tandem repeats per testis read</a:t>
            </a:r>
            <a:endParaRPr lang="en-DE" sz="1200" dirty="0"/>
          </a:p>
        </p:txBody>
      </p:sp>
      <p:sp>
        <p:nvSpPr>
          <p:cNvPr id="28" name="Rectangle 27">
            <a:extLst>
              <a:ext uri="{FF2B5EF4-FFF2-40B4-BE49-F238E27FC236}">
                <a16:creationId xmlns:a16="http://schemas.microsoft.com/office/drawing/2014/main" id="{89404F77-A2CD-4DEB-AB94-22625DE9ADCF}"/>
              </a:ext>
            </a:extLst>
          </p:cNvPr>
          <p:cNvSpPr/>
          <p:nvPr/>
        </p:nvSpPr>
        <p:spPr>
          <a:xfrm>
            <a:off x="6505861" y="519049"/>
            <a:ext cx="4485742" cy="42199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DE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1915A3F0-F196-4E34-AAB0-2913D64926C6}"/>
              </a:ext>
            </a:extLst>
          </p:cNvPr>
          <p:cNvSpPr txBox="1"/>
          <p:nvPr/>
        </p:nvSpPr>
        <p:spPr>
          <a:xfrm>
            <a:off x="1170690" y="3303329"/>
            <a:ext cx="3882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)</a:t>
            </a:r>
            <a:endParaRPr lang="en-DE" dirty="0"/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617E2400-5DFA-4BF3-B6E0-77CD6F5BF487}"/>
              </a:ext>
            </a:extLst>
          </p:cNvPr>
          <p:cNvSpPr txBox="1"/>
          <p:nvPr/>
        </p:nvSpPr>
        <p:spPr>
          <a:xfrm>
            <a:off x="6432492" y="3254285"/>
            <a:ext cx="38023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)</a:t>
            </a:r>
            <a:endParaRPr lang="en-DE" dirty="0"/>
          </a:p>
        </p:txBody>
      </p:sp>
    </p:spTree>
    <p:extLst>
      <p:ext uri="{BB962C8B-B14F-4D97-AF65-F5344CB8AC3E}">
        <p14:creationId xmlns:p14="http://schemas.microsoft.com/office/powerpoint/2010/main" val="311013270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572</TotalTime>
  <Words>516</Words>
  <Application>Microsoft Office PowerPoint</Application>
  <PresentationFormat>Widescreen</PresentationFormat>
  <Paragraphs>51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kob Mueller</dc:creator>
  <cp:lastModifiedBy>Jakob Mueller</cp:lastModifiedBy>
  <cp:revision>272</cp:revision>
  <cp:lastPrinted>2022-05-11T11:23:29Z</cp:lastPrinted>
  <dcterms:created xsi:type="dcterms:W3CDTF">2022-05-06T09:40:25Z</dcterms:created>
  <dcterms:modified xsi:type="dcterms:W3CDTF">2023-04-19T11:36:33Z</dcterms:modified>
</cp:coreProperties>
</file>